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6" r:id="rId8"/>
    <p:sldId id="268" r:id="rId9"/>
    <p:sldId id="270" r:id="rId10"/>
    <p:sldId id="271" r:id="rId11"/>
    <p:sldId id="272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4" autoAdjust="0"/>
    <p:restoredTop sz="94660"/>
  </p:normalViewPr>
  <p:slideViewPr>
    <p:cSldViewPr snapToGrid="0">
      <p:cViewPr varScale="1">
        <p:scale>
          <a:sx n="88" d="100"/>
          <a:sy n="88" d="100"/>
        </p:scale>
        <p:origin x="40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Seoul_Subway\Data\Subway_Phylum_All_16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5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cap="all" spc="150" baseline="0">
                <a:solidFill>
                  <a:srgbClr val="FF0000"/>
                </a:solidFill>
                <a:latin typeface="+mn-lt"/>
                <a:ea typeface="+mn-ea"/>
                <a:cs typeface="+mn-cs"/>
              </a:defRPr>
            </a:pPr>
            <a:r>
              <a:rPr lang="en-US" sz="1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thly Comparison of Bacterial Communities at SMRT Stations</a:t>
            </a:r>
          </a:p>
        </c:rich>
      </c:tx>
      <c:layout>
        <c:manualLayout>
          <c:xMode val="edge"/>
          <c:yMode val="edge"/>
          <c:x val="0.1526053540752661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cap="all" spc="150" baseline="0">
              <a:solidFill>
                <a:srgbClr val="FF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 w="19050" cap="flat" cmpd="sng" algn="ctr">
          <a:solidFill>
            <a:schemeClr val="tx1">
              <a:lumMod val="25000"/>
              <a:lumOff val="75000"/>
            </a:schemeClr>
          </a:solidFill>
          <a:round/>
        </a:ln>
        <a:effectLst/>
        <a:sp3d contourW="19050">
          <a:contourClr>
            <a:schemeClr val="tx1">
              <a:lumMod val="25000"/>
              <a:lumOff val="75000"/>
            </a:schemeClr>
          </a:contourClr>
        </a:sp3d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percentStacked"/>
        <c:varyColors val="0"/>
        <c:ser>
          <c:idx val="0"/>
          <c:order val="0"/>
          <c:tx>
            <c:strRef>
              <c:f>Monthly_Comparison_Manuscript!$Z$21</c:f>
              <c:strCache>
                <c:ptCount val="1"/>
                <c:pt idx="0">
                  <c:v>Actinobacteria</c:v>
                </c:pt>
              </c:strCache>
            </c:strRef>
          </c:tx>
          <c:spPr>
            <a:pattFill prst="ltDnDiag">
              <a:fgClr>
                <a:schemeClr val="accent1"/>
              </a:fgClr>
              <a:bgClr>
                <a:schemeClr val="accent1">
                  <a:lumMod val="20000"/>
                  <a:lumOff val="80000"/>
                </a:schemeClr>
              </a:bgClr>
            </a:patt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Monthly_Comparison_Manuscript!$Y$22:$Y$31</c:f>
              <c:strCache>
                <c:ptCount val="10"/>
                <c:pt idx="0">
                  <c:v>Feb19_A</c:v>
                </c:pt>
                <c:pt idx="1">
                  <c:v>Feb19_B</c:v>
                </c:pt>
                <c:pt idx="2">
                  <c:v>Feb19_C</c:v>
                </c:pt>
                <c:pt idx="3">
                  <c:v>Apr19_A</c:v>
                </c:pt>
                <c:pt idx="4">
                  <c:v>Apr19-B</c:v>
                </c:pt>
                <c:pt idx="5">
                  <c:v>Ap19_C</c:v>
                </c:pt>
                <c:pt idx="6">
                  <c:v>Jun19-C</c:v>
                </c:pt>
                <c:pt idx="7">
                  <c:v>Jun19_A</c:v>
                </c:pt>
                <c:pt idx="8">
                  <c:v>Jun19_B</c:v>
                </c:pt>
                <c:pt idx="9">
                  <c:v>Jun19_B</c:v>
                </c:pt>
              </c:strCache>
            </c:strRef>
          </c:cat>
          <c:val>
            <c:numRef>
              <c:f>Monthly_Comparison_Manuscript!$Z$22:$Z$31</c:f>
              <c:numCache>
                <c:formatCode>0.0</c:formatCode>
                <c:ptCount val="10"/>
                <c:pt idx="0">
                  <c:v>37.67</c:v>
                </c:pt>
                <c:pt idx="1">
                  <c:v>40.6</c:v>
                </c:pt>
                <c:pt idx="2">
                  <c:v>44.44</c:v>
                </c:pt>
                <c:pt idx="3">
                  <c:v>44.057099999999998</c:v>
                </c:pt>
                <c:pt idx="4">
                  <c:v>36.644799999999996</c:v>
                </c:pt>
                <c:pt idx="5">
                  <c:v>36.551200000000001</c:v>
                </c:pt>
                <c:pt idx="6">
                  <c:v>37.575000000000003</c:v>
                </c:pt>
                <c:pt idx="7">
                  <c:v>45.255000000000003</c:v>
                </c:pt>
                <c:pt idx="8">
                  <c:v>37.53</c:v>
                </c:pt>
                <c:pt idx="9">
                  <c:v>38.36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74-425C-8AE2-95D0D77BE626}"/>
            </c:ext>
          </c:extLst>
        </c:ser>
        <c:ser>
          <c:idx val="1"/>
          <c:order val="1"/>
          <c:tx>
            <c:strRef>
              <c:f>Monthly_Comparison_Manuscript!$AA$21</c:f>
              <c:strCache>
                <c:ptCount val="1"/>
                <c:pt idx="0">
                  <c:v>Bacteroidetes</c:v>
                </c:pt>
              </c:strCache>
            </c:strRef>
          </c:tx>
          <c:spPr>
            <a:pattFill prst="ltDnDiag">
              <a:fgClr>
                <a:schemeClr val="accent2"/>
              </a:fgClr>
              <a:bgClr>
                <a:schemeClr val="accent2">
                  <a:lumMod val="20000"/>
                  <a:lumOff val="80000"/>
                </a:schemeClr>
              </a:bgClr>
            </a:pattFill>
            <a:ln>
              <a:solidFill>
                <a:schemeClr val="accent2"/>
              </a:solidFill>
            </a:ln>
            <a:effectLst/>
            <a:sp3d>
              <a:contourClr>
                <a:schemeClr val="accent2"/>
              </a:contourClr>
            </a:sp3d>
          </c:spPr>
          <c:invertIfNegative val="0"/>
          <c:cat>
            <c:strRef>
              <c:f>Monthly_Comparison_Manuscript!$Y$22:$Y$31</c:f>
              <c:strCache>
                <c:ptCount val="10"/>
                <c:pt idx="0">
                  <c:v>Feb19_A</c:v>
                </c:pt>
                <c:pt idx="1">
                  <c:v>Feb19_B</c:v>
                </c:pt>
                <c:pt idx="2">
                  <c:v>Feb19_C</c:v>
                </c:pt>
                <c:pt idx="3">
                  <c:v>Apr19_A</c:v>
                </c:pt>
                <c:pt idx="4">
                  <c:v>Apr19-B</c:v>
                </c:pt>
                <c:pt idx="5">
                  <c:v>Ap19_C</c:v>
                </c:pt>
                <c:pt idx="6">
                  <c:v>Jun19-C</c:v>
                </c:pt>
                <c:pt idx="7">
                  <c:v>Jun19_A</c:v>
                </c:pt>
                <c:pt idx="8">
                  <c:v>Jun19_B</c:v>
                </c:pt>
                <c:pt idx="9">
                  <c:v>Jun19_B</c:v>
                </c:pt>
              </c:strCache>
            </c:strRef>
          </c:cat>
          <c:val>
            <c:numRef>
              <c:f>Monthly_Comparison_Manuscript!$AA$22:$AA$31</c:f>
              <c:numCache>
                <c:formatCode>0.0</c:formatCode>
                <c:ptCount val="10"/>
                <c:pt idx="0">
                  <c:v>6.96</c:v>
                </c:pt>
                <c:pt idx="1">
                  <c:v>4.3049999999999997</c:v>
                </c:pt>
                <c:pt idx="2">
                  <c:v>2.77</c:v>
                </c:pt>
                <c:pt idx="3">
                  <c:v>0</c:v>
                </c:pt>
                <c:pt idx="4">
                  <c:v>2.1429</c:v>
                </c:pt>
                <c:pt idx="5">
                  <c:v>5.11E-2</c:v>
                </c:pt>
                <c:pt idx="6">
                  <c:v>3.1749999999999998</c:v>
                </c:pt>
                <c:pt idx="7">
                  <c:v>3.585</c:v>
                </c:pt>
                <c:pt idx="8">
                  <c:v>3.71</c:v>
                </c:pt>
                <c:pt idx="9">
                  <c:v>6.964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074-425C-8AE2-95D0D77BE626}"/>
            </c:ext>
          </c:extLst>
        </c:ser>
        <c:ser>
          <c:idx val="2"/>
          <c:order val="2"/>
          <c:tx>
            <c:strRef>
              <c:f>Monthly_Comparison_Manuscript!$AB$21</c:f>
              <c:strCache>
                <c:ptCount val="1"/>
                <c:pt idx="0">
                  <c:v>Chloroflexi</c:v>
                </c:pt>
              </c:strCache>
            </c:strRef>
          </c:tx>
          <c:spPr>
            <a:pattFill prst="ltDnDiag">
              <a:fgClr>
                <a:schemeClr val="accent3"/>
              </a:fgClr>
              <a:bgClr>
                <a:schemeClr val="accent3">
                  <a:lumMod val="20000"/>
                  <a:lumOff val="80000"/>
                </a:schemeClr>
              </a:bgClr>
            </a:pattFill>
            <a:ln>
              <a:solidFill>
                <a:schemeClr val="accent3"/>
              </a:solidFill>
            </a:ln>
            <a:effectLst/>
            <a:sp3d>
              <a:contourClr>
                <a:schemeClr val="accent3"/>
              </a:contourClr>
            </a:sp3d>
          </c:spPr>
          <c:invertIfNegative val="0"/>
          <c:cat>
            <c:strRef>
              <c:f>Monthly_Comparison_Manuscript!$Y$22:$Y$31</c:f>
              <c:strCache>
                <c:ptCount val="10"/>
                <c:pt idx="0">
                  <c:v>Feb19_A</c:v>
                </c:pt>
                <c:pt idx="1">
                  <c:v>Feb19_B</c:v>
                </c:pt>
                <c:pt idx="2">
                  <c:v>Feb19_C</c:v>
                </c:pt>
                <c:pt idx="3">
                  <c:v>Apr19_A</c:v>
                </c:pt>
                <c:pt idx="4">
                  <c:v>Apr19-B</c:v>
                </c:pt>
                <c:pt idx="5">
                  <c:v>Ap19_C</c:v>
                </c:pt>
                <c:pt idx="6">
                  <c:v>Jun19-C</c:v>
                </c:pt>
                <c:pt idx="7">
                  <c:v>Jun19_A</c:v>
                </c:pt>
                <c:pt idx="8">
                  <c:v>Jun19_B</c:v>
                </c:pt>
                <c:pt idx="9">
                  <c:v>Jun19_B</c:v>
                </c:pt>
              </c:strCache>
            </c:strRef>
          </c:cat>
          <c:val>
            <c:numRef>
              <c:f>Monthly_Comparison_Manuscript!$AB$22:$AB$31</c:f>
              <c:numCache>
                <c:formatCode>0.0</c:formatCode>
                <c:ptCount val="10"/>
                <c:pt idx="0">
                  <c:v>0</c:v>
                </c:pt>
                <c:pt idx="1">
                  <c:v>1.2450000000000001</c:v>
                </c:pt>
                <c:pt idx="2">
                  <c:v>1.9350000000000001</c:v>
                </c:pt>
                <c:pt idx="3">
                  <c:v>1.9099999999999999E-2</c:v>
                </c:pt>
                <c:pt idx="4">
                  <c:v>1.4875</c:v>
                </c:pt>
                <c:pt idx="5">
                  <c:v>0</c:v>
                </c:pt>
                <c:pt idx="6">
                  <c:v>1.1399999999999999</c:v>
                </c:pt>
                <c:pt idx="7">
                  <c:v>0.85</c:v>
                </c:pt>
                <c:pt idx="8">
                  <c:v>1.4999999999999999E-2</c:v>
                </c:pt>
                <c:pt idx="9">
                  <c:v>0.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074-425C-8AE2-95D0D77BE626}"/>
            </c:ext>
          </c:extLst>
        </c:ser>
        <c:ser>
          <c:idx val="3"/>
          <c:order val="3"/>
          <c:tx>
            <c:strRef>
              <c:f>Monthly_Comparison_Manuscript!$AC$21</c:f>
              <c:strCache>
                <c:ptCount val="1"/>
                <c:pt idx="0">
                  <c:v>Cyanobacteria</c:v>
                </c:pt>
              </c:strCache>
            </c:strRef>
          </c:tx>
          <c:spPr>
            <a:pattFill prst="ltDnDiag">
              <a:fgClr>
                <a:schemeClr val="accent4"/>
              </a:fgClr>
              <a:bgClr>
                <a:schemeClr val="accent4">
                  <a:lumMod val="20000"/>
                  <a:lumOff val="80000"/>
                </a:schemeClr>
              </a:bgClr>
            </a:pattFill>
            <a:ln>
              <a:solidFill>
                <a:schemeClr val="accent4"/>
              </a:solidFill>
            </a:ln>
            <a:effectLst/>
            <a:sp3d>
              <a:contourClr>
                <a:schemeClr val="accent4"/>
              </a:contourClr>
            </a:sp3d>
          </c:spPr>
          <c:invertIfNegative val="0"/>
          <c:cat>
            <c:strRef>
              <c:f>Monthly_Comparison_Manuscript!$Y$22:$Y$31</c:f>
              <c:strCache>
                <c:ptCount val="10"/>
                <c:pt idx="0">
                  <c:v>Feb19_A</c:v>
                </c:pt>
                <c:pt idx="1">
                  <c:v>Feb19_B</c:v>
                </c:pt>
                <c:pt idx="2">
                  <c:v>Feb19_C</c:v>
                </c:pt>
                <c:pt idx="3">
                  <c:v>Apr19_A</c:v>
                </c:pt>
                <c:pt idx="4">
                  <c:v>Apr19-B</c:v>
                </c:pt>
                <c:pt idx="5">
                  <c:v>Ap19_C</c:v>
                </c:pt>
                <c:pt idx="6">
                  <c:v>Jun19-C</c:v>
                </c:pt>
                <c:pt idx="7">
                  <c:v>Jun19_A</c:v>
                </c:pt>
                <c:pt idx="8">
                  <c:v>Jun19_B</c:v>
                </c:pt>
                <c:pt idx="9">
                  <c:v>Jun19_B</c:v>
                </c:pt>
              </c:strCache>
            </c:strRef>
          </c:cat>
          <c:val>
            <c:numRef>
              <c:f>Monthly_Comparison_Manuscript!$AC$22:$AC$31</c:f>
              <c:numCache>
                <c:formatCode>0.0</c:formatCode>
                <c:ptCount val="10"/>
                <c:pt idx="0">
                  <c:v>3.3450000000000002</c:v>
                </c:pt>
                <c:pt idx="1">
                  <c:v>4.1349999999999998</c:v>
                </c:pt>
                <c:pt idx="2">
                  <c:v>3.3</c:v>
                </c:pt>
                <c:pt idx="3">
                  <c:v>2.9830000000000001</c:v>
                </c:pt>
                <c:pt idx="4">
                  <c:v>16.455300000000001</c:v>
                </c:pt>
                <c:pt idx="5">
                  <c:v>7.3594999999999997</c:v>
                </c:pt>
                <c:pt idx="6">
                  <c:v>4.3449999999999998</c:v>
                </c:pt>
                <c:pt idx="7">
                  <c:v>3.645</c:v>
                </c:pt>
                <c:pt idx="8">
                  <c:v>5.625</c:v>
                </c:pt>
                <c:pt idx="9">
                  <c:v>4.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074-425C-8AE2-95D0D77BE626}"/>
            </c:ext>
          </c:extLst>
        </c:ser>
        <c:ser>
          <c:idx val="4"/>
          <c:order val="4"/>
          <c:tx>
            <c:strRef>
              <c:f>Monthly_Comparison_Manuscript!$AD$21</c:f>
              <c:strCache>
                <c:ptCount val="1"/>
                <c:pt idx="0">
                  <c:v>Deinococcus-Thermus</c:v>
                </c:pt>
              </c:strCache>
            </c:strRef>
          </c:tx>
          <c:spPr>
            <a:pattFill prst="ltDnDiag">
              <a:fgClr>
                <a:schemeClr val="accent5"/>
              </a:fgClr>
              <a:bgClr>
                <a:schemeClr val="accent5">
                  <a:lumMod val="20000"/>
                  <a:lumOff val="80000"/>
                </a:schemeClr>
              </a:bgClr>
            </a:pattFill>
            <a:ln>
              <a:solidFill>
                <a:schemeClr val="accent5"/>
              </a:solidFill>
            </a:ln>
            <a:effectLst/>
            <a:sp3d>
              <a:contourClr>
                <a:schemeClr val="accent5"/>
              </a:contourClr>
            </a:sp3d>
          </c:spPr>
          <c:invertIfNegative val="0"/>
          <c:cat>
            <c:strRef>
              <c:f>Monthly_Comparison_Manuscript!$Y$22:$Y$31</c:f>
              <c:strCache>
                <c:ptCount val="10"/>
                <c:pt idx="0">
                  <c:v>Feb19_A</c:v>
                </c:pt>
                <c:pt idx="1">
                  <c:v>Feb19_B</c:v>
                </c:pt>
                <c:pt idx="2">
                  <c:v>Feb19_C</c:v>
                </c:pt>
                <c:pt idx="3">
                  <c:v>Apr19_A</c:v>
                </c:pt>
                <c:pt idx="4">
                  <c:v>Apr19-B</c:v>
                </c:pt>
                <c:pt idx="5">
                  <c:v>Ap19_C</c:v>
                </c:pt>
                <c:pt idx="6">
                  <c:v>Jun19-C</c:v>
                </c:pt>
                <c:pt idx="7">
                  <c:v>Jun19_A</c:v>
                </c:pt>
                <c:pt idx="8">
                  <c:v>Jun19_B</c:v>
                </c:pt>
                <c:pt idx="9">
                  <c:v>Jun19_B</c:v>
                </c:pt>
              </c:strCache>
            </c:strRef>
          </c:cat>
          <c:val>
            <c:numRef>
              <c:f>Monthly_Comparison_Manuscript!$AD$22:$AD$31</c:f>
              <c:numCache>
                <c:formatCode>0.0</c:formatCode>
                <c:ptCount val="10"/>
                <c:pt idx="0">
                  <c:v>0.58499999999999996</c:v>
                </c:pt>
                <c:pt idx="1">
                  <c:v>3.74</c:v>
                </c:pt>
                <c:pt idx="2">
                  <c:v>0.93500000000000005</c:v>
                </c:pt>
                <c:pt idx="3">
                  <c:v>1.6468</c:v>
                </c:pt>
                <c:pt idx="4">
                  <c:v>4.7548000000000004</c:v>
                </c:pt>
                <c:pt idx="5">
                  <c:v>5.28E-2</c:v>
                </c:pt>
                <c:pt idx="6">
                  <c:v>9.77</c:v>
                </c:pt>
                <c:pt idx="7">
                  <c:v>4.0149999999999997</c:v>
                </c:pt>
                <c:pt idx="8">
                  <c:v>3.82</c:v>
                </c:pt>
                <c:pt idx="9">
                  <c:v>10.8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074-425C-8AE2-95D0D77BE626}"/>
            </c:ext>
          </c:extLst>
        </c:ser>
        <c:ser>
          <c:idx val="5"/>
          <c:order val="5"/>
          <c:tx>
            <c:strRef>
              <c:f>Monthly_Comparison_Manuscript!$AE$21</c:f>
              <c:strCache>
                <c:ptCount val="1"/>
                <c:pt idx="0">
                  <c:v>Firmicutes</c:v>
                </c:pt>
              </c:strCache>
            </c:strRef>
          </c:tx>
          <c:spPr>
            <a:pattFill prst="ltDnDiag">
              <a:fgClr>
                <a:schemeClr val="accent6"/>
              </a:fgClr>
              <a:bgClr>
                <a:schemeClr val="accent6">
                  <a:lumMod val="20000"/>
                  <a:lumOff val="80000"/>
                </a:schemeClr>
              </a:bgClr>
            </a:pattFill>
            <a:ln>
              <a:solidFill>
                <a:schemeClr val="accent6"/>
              </a:solidFill>
            </a:ln>
            <a:effectLst/>
            <a:sp3d>
              <a:contourClr>
                <a:schemeClr val="accent6"/>
              </a:contourClr>
            </a:sp3d>
          </c:spPr>
          <c:invertIfNegative val="0"/>
          <c:cat>
            <c:strRef>
              <c:f>Monthly_Comparison_Manuscript!$Y$22:$Y$31</c:f>
              <c:strCache>
                <c:ptCount val="10"/>
                <c:pt idx="0">
                  <c:v>Feb19_A</c:v>
                </c:pt>
                <c:pt idx="1">
                  <c:v>Feb19_B</c:v>
                </c:pt>
                <c:pt idx="2">
                  <c:v>Feb19_C</c:v>
                </c:pt>
                <c:pt idx="3">
                  <c:v>Apr19_A</c:v>
                </c:pt>
                <c:pt idx="4">
                  <c:v>Apr19-B</c:v>
                </c:pt>
                <c:pt idx="5">
                  <c:v>Ap19_C</c:v>
                </c:pt>
                <c:pt idx="6">
                  <c:v>Jun19-C</c:v>
                </c:pt>
                <c:pt idx="7">
                  <c:v>Jun19_A</c:v>
                </c:pt>
                <c:pt idx="8">
                  <c:v>Jun19_B</c:v>
                </c:pt>
                <c:pt idx="9">
                  <c:v>Jun19_B</c:v>
                </c:pt>
              </c:strCache>
            </c:strRef>
          </c:cat>
          <c:val>
            <c:numRef>
              <c:f>Monthly_Comparison_Manuscript!$AE$22:$AE$31</c:f>
              <c:numCache>
                <c:formatCode>0.0</c:formatCode>
                <c:ptCount val="10"/>
                <c:pt idx="0">
                  <c:v>13.455</c:v>
                </c:pt>
                <c:pt idx="1">
                  <c:v>13.135</c:v>
                </c:pt>
                <c:pt idx="2">
                  <c:v>18.535</c:v>
                </c:pt>
                <c:pt idx="3">
                  <c:v>10.630800000000001</c:v>
                </c:pt>
                <c:pt idx="4">
                  <c:v>10.1226</c:v>
                </c:pt>
                <c:pt idx="5">
                  <c:v>14.220800000000001</c:v>
                </c:pt>
                <c:pt idx="6">
                  <c:v>9.9350000000000005</c:v>
                </c:pt>
                <c:pt idx="7">
                  <c:v>7.18</c:v>
                </c:pt>
                <c:pt idx="8">
                  <c:v>11.05</c:v>
                </c:pt>
                <c:pt idx="9">
                  <c:v>16.01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074-425C-8AE2-95D0D77BE626}"/>
            </c:ext>
          </c:extLst>
        </c:ser>
        <c:ser>
          <c:idx val="6"/>
          <c:order val="6"/>
          <c:tx>
            <c:strRef>
              <c:f>Monthly_Comparison_Manuscript!$AF$21</c:f>
              <c:strCache>
                <c:ptCount val="1"/>
                <c:pt idx="0">
                  <c:v>Proteobacteria</c:v>
                </c:pt>
              </c:strCache>
            </c:strRef>
          </c:tx>
          <c:spPr>
            <a:pattFill prst="ltDnDiag">
              <a:fgClr>
                <a:schemeClr val="accent1">
                  <a:lumMod val="60000"/>
                </a:schemeClr>
              </a:fgClr>
              <a:bgClr>
                <a:schemeClr val="accent1">
                  <a:lumMod val="60000"/>
                  <a:lumMod val="20000"/>
                  <a:lumOff val="80000"/>
                </a:schemeClr>
              </a:bgClr>
            </a:pattFill>
            <a:ln>
              <a:solidFill>
                <a:schemeClr val="accent1">
                  <a:lumMod val="60000"/>
                </a:schemeClr>
              </a:solidFill>
            </a:ln>
            <a:effectLst/>
            <a:sp3d>
              <a:contourClr>
                <a:schemeClr val="accent1">
                  <a:lumMod val="60000"/>
                </a:schemeClr>
              </a:contourClr>
            </a:sp3d>
          </c:spPr>
          <c:invertIfNegative val="0"/>
          <c:cat>
            <c:strRef>
              <c:f>Monthly_Comparison_Manuscript!$Y$22:$Y$31</c:f>
              <c:strCache>
                <c:ptCount val="10"/>
                <c:pt idx="0">
                  <c:v>Feb19_A</c:v>
                </c:pt>
                <c:pt idx="1">
                  <c:v>Feb19_B</c:v>
                </c:pt>
                <c:pt idx="2">
                  <c:v>Feb19_C</c:v>
                </c:pt>
                <c:pt idx="3">
                  <c:v>Apr19_A</c:v>
                </c:pt>
                <c:pt idx="4">
                  <c:v>Apr19-B</c:v>
                </c:pt>
                <c:pt idx="5">
                  <c:v>Ap19_C</c:v>
                </c:pt>
                <c:pt idx="6">
                  <c:v>Jun19-C</c:v>
                </c:pt>
                <c:pt idx="7">
                  <c:v>Jun19_A</c:v>
                </c:pt>
                <c:pt idx="8">
                  <c:v>Jun19_B</c:v>
                </c:pt>
                <c:pt idx="9">
                  <c:v>Jun19_B</c:v>
                </c:pt>
              </c:strCache>
            </c:strRef>
          </c:cat>
          <c:val>
            <c:numRef>
              <c:f>Monthly_Comparison_Manuscript!$AF$22:$AF$31</c:f>
              <c:numCache>
                <c:formatCode>0.0</c:formatCode>
                <c:ptCount val="10"/>
                <c:pt idx="0">
                  <c:v>36.825000000000003</c:v>
                </c:pt>
                <c:pt idx="1">
                  <c:v>31.434999999999999</c:v>
                </c:pt>
                <c:pt idx="2">
                  <c:v>25.39</c:v>
                </c:pt>
                <c:pt idx="3">
                  <c:v>36.415599999999998</c:v>
                </c:pt>
                <c:pt idx="4">
                  <c:v>27.031400000000001</c:v>
                </c:pt>
                <c:pt idx="5">
                  <c:v>39.975700000000003</c:v>
                </c:pt>
                <c:pt idx="6">
                  <c:v>32.18</c:v>
                </c:pt>
                <c:pt idx="7">
                  <c:v>34.229999999999997</c:v>
                </c:pt>
                <c:pt idx="8">
                  <c:v>35.935000000000002</c:v>
                </c:pt>
                <c:pt idx="9">
                  <c:v>21.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074-425C-8AE2-95D0D77BE6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946926207"/>
        <c:axId val="946927871"/>
        <c:axId val="0"/>
      </c:bar3DChart>
      <c:catAx>
        <c:axId val="9469262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46927871"/>
        <c:crosses val="autoZero"/>
        <c:auto val="1"/>
        <c:lblAlgn val="ctr"/>
        <c:lblOffset val="100"/>
        <c:noMultiLvlLbl val="0"/>
      </c:catAx>
      <c:valAx>
        <c:axId val="946927871"/>
        <c:scaling>
          <c:orientation val="minMax"/>
        </c:scaling>
        <c:delete val="0"/>
        <c:axPos val="l"/>
        <c:majorGridlines>
          <c:spPr>
            <a:ln>
              <a:solidFill>
                <a:schemeClr val="tx1">
                  <a:lumMod val="15000"/>
                  <a:lumOff val="85000"/>
                </a:schemeClr>
              </a:solidFill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46926207"/>
        <c:crosses val="autoZero"/>
        <c:crossBetween val="between"/>
      </c:valAx>
      <c:spPr>
        <a:solidFill>
          <a:schemeClr val="bg1"/>
        </a:solidFill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5.0064818540018263E-2"/>
          <c:y val="0.1253652058432935"/>
          <c:w val="0.87959461271720596"/>
          <c:h val="6.966987692275517E-2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accent6">
        <a:lumMod val="40000"/>
        <a:lumOff val="60000"/>
      </a:schemeClr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cap="all" spc="15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jor Fungal Phyl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cap="all" spc="15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 w="19050" cap="flat" cmpd="sng" algn="ctr">
          <a:solidFill>
            <a:schemeClr val="tx1">
              <a:lumMod val="25000"/>
              <a:lumOff val="75000"/>
            </a:schemeClr>
          </a:solidFill>
          <a:round/>
        </a:ln>
        <a:effectLst/>
        <a:sp3d contourW="19050">
          <a:contourClr>
            <a:schemeClr val="tx1">
              <a:lumMod val="25000"/>
              <a:lumOff val="75000"/>
            </a:schemeClr>
          </a:contourClr>
        </a:sp3d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percentStacked"/>
        <c:varyColors val="0"/>
        <c:ser>
          <c:idx val="0"/>
          <c:order val="0"/>
          <c:tx>
            <c:strRef>
              <c:f>ITS_Phylum_Month!$A$2</c:f>
              <c:strCache>
                <c:ptCount val="1"/>
                <c:pt idx="0">
                  <c:v>Anthophyta</c:v>
                </c:pt>
              </c:strCache>
            </c:strRef>
          </c:tx>
          <c:spPr>
            <a:pattFill prst="ltDnDiag">
              <a:fgClr>
                <a:schemeClr val="accent2"/>
              </a:fgClr>
              <a:bgClr>
                <a:schemeClr val="accent2">
                  <a:lumMod val="20000"/>
                  <a:lumOff val="80000"/>
                </a:schemeClr>
              </a:bgClr>
            </a:pattFill>
            <a:ln>
              <a:solidFill>
                <a:schemeClr val="accent2"/>
              </a:solidFill>
            </a:ln>
            <a:effectLst/>
            <a:sp3d>
              <a:contourClr>
                <a:schemeClr val="accent2"/>
              </a:contourClr>
            </a:sp3d>
          </c:spPr>
          <c:invertIfNegative val="0"/>
          <c:cat>
            <c:strRef>
              <c:f>ITS_Phylum_Month!$B$1:$J$1</c:f>
              <c:strCache>
                <c:ptCount val="9"/>
                <c:pt idx="0">
                  <c:v>Feb19_SU</c:v>
                </c:pt>
                <c:pt idx="1">
                  <c:v>Apr19-SU</c:v>
                </c:pt>
                <c:pt idx="2">
                  <c:v>Jun19_SU</c:v>
                </c:pt>
                <c:pt idx="3">
                  <c:v>Feb19_Gan</c:v>
                </c:pt>
                <c:pt idx="4">
                  <c:v>Apr19-Gan</c:v>
                </c:pt>
                <c:pt idx="5">
                  <c:v>Jun19_Gan</c:v>
                </c:pt>
                <c:pt idx="6">
                  <c:v>Feb19_Ind</c:v>
                </c:pt>
                <c:pt idx="7">
                  <c:v>Apr19_Ind</c:v>
                </c:pt>
                <c:pt idx="8">
                  <c:v>Jun19-Ind</c:v>
                </c:pt>
              </c:strCache>
            </c:strRef>
          </c:cat>
          <c:val>
            <c:numRef>
              <c:f>ITS_Phylum_Month!$B$2:$J$2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.37</c:v>
                </c:pt>
                <c:pt idx="3">
                  <c:v>14.45</c:v>
                </c:pt>
                <c:pt idx="4">
                  <c:v>0</c:v>
                </c:pt>
                <c:pt idx="5">
                  <c:v>0</c:v>
                </c:pt>
                <c:pt idx="6">
                  <c:v>0.02</c:v>
                </c:pt>
                <c:pt idx="7">
                  <c:v>0</c:v>
                </c:pt>
                <c:pt idx="8">
                  <c:v>0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E4-4A94-AD3B-B5947B7634CB}"/>
            </c:ext>
          </c:extLst>
        </c:ser>
        <c:ser>
          <c:idx val="1"/>
          <c:order val="1"/>
          <c:tx>
            <c:strRef>
              <c:f>ITS_Phylum_Month!$A$3</c:f>
              <c:strCache>
                <c:ptCount val="1"/>
                <c:pt idx="0">
                  <c:v>Ascomycota</c:v>
                </c:pt>
              </c:strCache>
            </c:strRef>
          </c:tx>
          <c:spPr>
            <a:pattFill prst="ltDnDiag">
              <a:fgClr>
                <a:schemeClr val="accent4"/>
              </a:fgClr>
              <a:bgClr>
                <a:schemeClr val="accent4">
                  <a:lumMod val="20000"/>
                  <a:lumOff val="80000"/>
                </a:schemeClr>
              </a:bgClr>
            </a:pattFill>
            <a:ln>
              <a:solidFill>
                <a:schemeClr val="accent4"/>
              </a:solidFill>
            </a:ln>
            <a:effectLst/>
            <a:sp3d>
              <a:contourClr>
                <a:schemeClr val="accent4"/>
              </a:contourClr>
            </a:sp3d>
          </c:spPr>
          <c:invertIfNegative val="0"/>
          <c:cat>
            <c:strRef>
              <c:f>ITS_Phylum_Month!$B$1:$J$1</c:f>
              <c:strCache>
                <c:ptCount val="9"/>
                <c:pt idx="0">
                  <c:v>Feb19_SU</c:v>
                </c:pt>
                <c:pt idx="1">
                  <c:v>Apr19-SU</c:v>
                </c:pt>
                <c:pt idx="2">
                  <c:v>Jun19_SU</c:v>
                </c:pt>
                <c:pt idx="3">
                  <c:v>Feb19_Gan</c:v>
                </c:pt>
                <c:pt idx="4">
                  <c:v>Apr19-Gan</c:v>
                </c:pt>
                <c:pt idx="5">
                  <c:v>Jun19_Gan</c:v>
                </c:pt>
                <c:pt idx="6">
                  <c:v>Feb19_Ind</c:v>
                </c:pt>
                <c:pt idx="7">
                  <c:v>Apr19_Ind</c:v>
                </c:pt>
                <c:pt idx="8">
                  <c:v>Jun19-Ind</c:v>
                </c:pt>
              </c:strCache>
            </c:strRef>
          </c:cat>
          <c:val>
            <c:numRef>
              <c:f>ITS_Phylum_Month!$B$3:$J$3</c:f>
              <c:numCache>
                <c:formatCode>General</c:formatCode>
                <c:ptCount val="9"/>
                <c:pt idx="0">
                  <c:v>63.89</c:v>
                </c:pt>
                <c:pt idx="1">
                  <c:v>57.21</c:v>
                </c:pt>
                <c:pt idx="2">
                  <c:v>50.37</c:v>
                </c:pt>
                <c:pt idx="3">
                  <c:v>39.409999999999997</c:v>
                </c:pt>
                <c:pt idx="4">
                  <c:v>56.65</c:v>
                </c:pt>
                <c:pt idx="5">
                  <c:v>17.66</c:v>
                </c:pt>
                <c:pt idx="6">
                  <c:v>90.22</c:v>
                </c:pt>
                <c:pt idx="7">
                  <c:v>95.26</c:v>
                </c:pt>
                <c:pt idx="8">
                  <c:v>34.36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8E4-4A94-AD3B-B5947B7634CB}"/>
            </c:ext>
          </c:extLst>
        </c:ser>
        <c:ser>
          <c:idx val="2"/>
          <c:order val="2"/>
          <c:tx>
            <c:strRef>
              <c:f>ITS_Phylum_Month!$A$4</c:f>
              <c:strCache>
                <c:ptCount val="1"/>
                <c:pt idx="0">
                  <c:v>Basidiomycota</c:v>
                </c:pt>
              </c:strCache>
            </c:strRef>
          </c:tx>
          <c:spPr>
            <a:pattFill prst="ltDnDiag">
              <a:fgClr>
                <a:schemeClr val="accent6"/>
              </a:fgClr>
              <a:bgClr>
                <a:schemeClr val="accent6">
                  <a:lumMod val="20000"/>
                  <a:lumOff val="80000"/>
                </a:schemeClr>
              </a:bgClr>
            </a:pattFill>
            <a:ln>
              <a:solidFill>
                <a:schemeClr val="accent6"/>
              </a:solidFill>
            </a:ln>
            <a:effectLst/>
            <a:sp3d>
              <a:contourClr>
                <a:schemeClr val="accent6"/>
              </a:contourClr>
            </a:sp3d>
          </c:spPr>
          <c:invertIfNegative val="0"/>
          <c:cat>
            <c:strRef>
              <c:f>ITS_Phylum_Month!$B$1:$J$1</c:f>
              <c:strCache>
                <c:ptCount val="9"/>
                <c:pt idx="0">
                  <c:v>Feb19_SU</c:v>
                </c:pt>
                <c:pt idx="1">
                  <c:v>Apr19-SU</c:v>
                </c:pt>
                <c:pt idx="2">
                  <c:v>Jun19_SU</c:v>
                </c:pt>
                <c:pt idx="3">
                  <c:v>Feb19_Gan</c:v>
                </c:pt>
                <c:pt idx="4">
                  <c:v>Apr19-Gan</c:v>
                </c:pt>
                <c:pt idx="5">
                  <c:v>Jun19_Gan</c:v>
                </c:pt>
                <c:pt idx="6">
                  <c:v>Feb19_Ind</c:v>
                </c:pt>
                <c:pt idx="7">
                  <c:v>Apr19_Ind</c:v>
                </c:pt>
                <c:pt idx="8">
                  <c:v>Jun19-Ind</c:v>
                </c:pt>
              </c:strCache>
            </c:strRef>
          </c:cat>
          <c:val>
            <c:numRef>
              <c:f>ITS_Phylum_Month!$B$4:$J$4</c:f>
              <c:numCache>
                <c:formatCode>General</c:formatCode>
                <c:ptCount val="9"/>
                <c:pt idx="0">
                  <c:v>4.5999999999999996</c:v>
                </c:pt>
                <c:pt idx="1">
                  <c:v>11.97</c:v>
                </c:pt>
                <c:pt idx="2">
                  <c:v>26.73</c:v>
                </c:pt>
                <c:pt idx="3">
                  <c:v>12.1</c:v>
                </c:pt>
                <c:pt idx="4">
                  <c:v>28.36</c:v>
                </c:pt>
                <c:pt idx="5">
                  <c:v>64.040000000000006</c:v>
                </c:pt>
                <c:pt idx="6">
                  <c:v>3.86</c:v>
                </c:pt>
                <c:pt idx="7">
                  <c:v>2.2799999999999998</c:v>
                </c:pt>
                <c:pt idx="8">
                  <c:v>18.32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8E4-4A94-AD3B-B5947B7634CB}"/>
            </c:ext>
          </c:extLst>
        </c:ser>
        <c:ser>
          <c:idx val="3"/>
          <c:order val="3"/>
          <c:tx>
            <c:strRef>
              <c:f>ITS_Phylum_Month!$A$5</c:f>
              <c:strCache>
                <c:ptCount val="1"/>
                <c:pt idx="0">
                  <c:v>Chytridiomycota</c:v>
                </c:pt>
              </c:strCache>
            </c:strRef>
          </c:tx>
          <c:spPr>
            <a:pattFill prst="ltDnDiag">
              <a:fgClr>
                <a:schemeClr val="accent2">
                  <a:lumMod val="60000"/>
                </a:schemeClr>
              </a:fgClr>
              <a:bgClr>
                <a:schemeClr val="accent2">
                  <a:lumMod val="60000"/>
                  <a:lumMod val="20000"/>
                  <a:lumOff val="80000"/>
                </a:schemeClr>
              </a:bgClr>
            </a:pattFill>
            <a:ln>
              <a:solidFill>
                <a:schemeClr val="accent2">
                  <a:lumMod val="60000"/>
                </a:schemeClr>
              </a:solidFill>
            </a:ln>
            <a:effectLst/>
            <a:sp3d>
              <a:contourClr>
                <a:schemeClr val="accent2">
                  <a:lumMod val="60000"/>
                </a:schemeClr>
              </a:contourClr>
            </a:sp3d>
          </c:spPr>
          <c:invertIfNegative val="0"/>
          <c:cat>
            <c:strRef>
              <c:f>ITS_Phylum_Month!$B$1:$J$1</c:f>
              <c:strCache>
                <c:ptCount val="9"/>
                <c:pt idx="0">
                  <c:v>Feb19_SU</c:v>
                </c:pt>
                <c:pt idx="1">
                  <c:v>Apr19-SU</c:v>
                </c:pt>
                <c:pt idx="2">
                  <c:v>Jun19_SU</c:v>
                </c:pt>
                <c:pt idx="3">
                  <c:v>Feb19_Gan</c:v>
                </c:pt>
                <c:pt idx="4">
                  <c:v>Apr19-Gan</c:v>
                </c:pt>
                <c:pt idx="5">
                  <c:v>Jun19_Gan</c:v>
                </c:pt>
                <c:pt idx="6">
                  <c:v>Feb19_Ind</c:v>
                </c:pt>
                <c:pt idx="7">
                  <c:v>Apr19_Ind</c:v>
                </c:pt>
                <c:pt idx="8">
                  <c:v>Jun19-Ind</c:v>
                </c:pt>
              </c:strCache>
            </c:strRef>
          </c:cat>
          <c:val>
            <c:numRef>
              <c:f>ITS_Phylum_Month!$B$5:$J$5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.18</c:v>
                </c:pt>
                <c:pt idx="3">
                  <c:v>1.27</c:v>
                </c:pt>
                <c:pt idx="4">
                  <c:v>0</c:v>
                </c:pt>
                <c:pt idx="5">
                  <c:v>6.22</c:v>
                </c:pt>
                <c:pt idx="6">
                  <c:v>0</c:v>
                </c:pt>
                <c:pt idx="7">
                  <c:v>0</c:v>
                </c:pt>
                <c:pt idx="8">
                  <c:v>0.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8E4-4A94-AD3B-B5947B7634CB}"/>
            </c:ext>
          </c:extLst>
        </c:ser>
        <c:ser>
          <c:idx val="4"/>
          <c:order val="4"/>
          <c:tx>
            <c:strRef>
              <c:f>ITS_Phylum_Month!$A$6</c:f>
              <c:strCache>
                <c:ptCount val="1"/>
                <c:pt idx="0">
                  <c:v>Fungi_p</c:v>
                </c:pt>
              </c:strCache>
            </c:strRef>
          </c:tx>
          <c:spPr>
            <a:pattFill prst="ltDnDiag">
              <a:fgClr>
                <a:schemeClr val="accent4">
                  <a:lumMod val="60000"/>
                </a:schemeClr>
              </a:fgClr>
              <a:bgClr>
                <a:schemeClr val="accent4">
                  <a:lumMod val="60000"/>
                  <a:lumMod val="20000"/>
                  <a:lumOff val="80000"/>
                </a:schemeClr>
              </a:bgClr>
            </a:pattFill>
            <a:ln>
              <a:solidFill>
                <a:schemeClr val="accent4">
                  <a:lumMod val="60000"/>
                </a:schemeClr>
              </a:solidFill>
            </a:ln>
            <a:effectLst/>
            <a:sp3d>
              <a:contourClr>
                <a:schemeClr val="accent4">
                  <a:lumMod val="60000"/>
                </a:schemeClr>
              </a:contourClr>
            </a:sp3d>
          </c:spPr>
          <c:invertIfNegative val="0"/>
          <c:cat>
            <c:strRef>
              <c:f>ITS_Phylum_Month!$B$1:$J$1</c:f>
              <c:strCache>
                <c:ptCount val="9"/>
                <c:pt idx="0">
                  <c:v>Feb19_SU</c:v>
                </c:pt>
                <c:pt idx="1">
                  <c:v>Apr19-SU</c:v>
                </c:pt>
                <c:pt idx="2">
                  <c:v>Jun19_SU</c:v>
                </c:pt>
                <c:pt idx="3">
                  <c:v>Feb19_Gan</c:v>
                </c:pt>
                <c:pt idx="4">
                  <c:v>Apr19-Gan</c:v>
                </c:pt>
                <c:pt idx="5">
                  <c:v>Jun19_Gan</c:v>
                </c:pt>
                <c:pt idx="6">
                  <c:v>Feb19_Ind</c:v>
                </c:pt>
                <c:pt idx="7">
                  <c:v>Apr19_Ind</c:v>
                </c:pt>
                <c:pt idx="8">
                  <c:v>Jun19-Ind</c:v>
                </c:pt>
              </c:strCache>
            </c:strRef>
          </c:cat>
          <c:val>
            <c:numRef>
              <c:f>ITS_Phylum_Month!$B$6:$J$6</c:f>
              <c:numCache>
                <c:formatCode>General</c:formatCode>
                <c:ptCount val="9"/>
                <c:pt idx="0">
                  <c:v>5.57</c:v>
                </c:pt>
                <c:pt idx="1">
                  <c:v>0.01</c:v>
                </c:pt>
                <c:pt idx="2">
                  <c:v>14.31</c:v>
                </c:pt>
                <c:pt idx="3">
                  <c:v>3.52</c:v>
                </c:pt>
                <c:pt idx="4">
                  <c:v>3.98</c:v>
                </c:pt>
                <c:pt idx="5">
                  <c:v>7.35</c:v>
                </c:pt>
                <c:pt idx="6">
                  <c:v>2.13</c:v>
                </c:pt>
                <c:pt idx="7">
                  <c:v>1.33</c:v>
                </c:pt>
                <c:pt idx="8">
                  <c:v>9.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8E4-4A94-AD3B-B5947B7634CB}"/>
            </c:ext>
          </c:extLst>
        </c:ser>
        <c:ser>
          <c:idx val="5"/>
          <c:order val="5"/>
          <c:tx>
            <c:strRef>
              <c:f>ITS_Phylum_Month!$A$7</c:f>
              <c:strCache>
                <c:ptCount val="1"/>
                <c:pt idx="0">
                  <c:v>Mucoromycota</c:v>
                </c:pt>
              </c:strCache>
            </c:strRef>
          </c:tx>
          <c:spPr>
            <a:pattFill prst="ltDnDiag">
              <a:fgClr>
                <a:schemeClr val="accent6">
                  <a:lumMod val="60000"/>
                </a:schemeClr>
              </a:fgClr>
              <a:bgClr>
                <a:schemeClr val="accent6">
                  <a:lumMod val="60000"/>
                  <a:lumMod val="20000"/>
                  <a:lumOff val="80000"/>
                </a:schemeClr>
              </a:bgClr>
            </a:pattFill>
            <a:ln>
              <a:solidFill>
                <a:schemeClr val="accent6">
                  <a:lumMod val="60000"/>
                </a:schemeClr>
              </a:solidFill>
            </a:ln>
            <a:effectLst/>
            <a:sp3d>
              <a:contourClr>
                <a:schemeClr val="accent6">
                  <a:lumMod val="60000"/>
                </a:schemeClr>
              </a:contourClr>
            </a:sp3d>
          </c:spPr>
          <c:invertIfNegative val="0"/>
          <c:cat>
            <c:strRef>
              <c:f>ITS_Phylum_Month!$B$1:$J$1</c:f>
              <c:strCache>
                <c:ptCount val="9"/>
                <c:pt idx="0">
                  <c:v>Feb19_SU</c:v>
                </c:pt>
                <c:pt idx="1">
                  <c:v>Apr19-SU</c:v>
                </c:pt>
                <c:pt idx="2">
                  <c:v>Jun19_SU</c:v>
                </c:pt>
                <c:pt idx="3">
                  <c:v>Feb19_Gan</c:v>
                </c:pt>
                <c:pt idx="4">
                  <c:v>Apr19-Gan</c:v>
                </c:pt>
                <c:pt idx="5">
                  <c:v>Jun19_Gan</c:v>
                </c:pt>
                <c:pt idx="6">
                  <c:v>Feb19_Ind</c:v>
                </c:pt>
                <c:pt idx="7">
                  <c:v>Apr19_Ind</c:v>
                </c:pt>
                <c:pt idx="8">
                  <c:v>Jun19-Ind</c:v>
                </c:pt>
              </c:strCache>
            </c:strRef>
          </c:cat>
          <c:val>
            <c:numRef>
              <c:f>ITS_Phylum_Month!$B$7:$J$7</c:f>
              <c:numCache>
                <c:formatCode>General</c:formatCode>
                <c:ptCount val="9"/>
                <c:pt idx="0">
                  <c:v>0.11</c:v>
                </c:pt>
                <c:pt idx="1">
                  <c:v>0.95</c:v>
                </c:pt>
                <c:pt idx="2">
                  <c:v>1.8</c:v>
                </c:pt>
                <c:pt idx="3">
                  <c:v>0.35</c:v>
                </c:pt>
                <c:pt idx="4">
                  <c:v>0.66</c:v>
                </c:pt>
                <c:pt idx="5">
                  <c:v>0.1</c:v>
                </c:pt>
                <c:pt idx="6">
                  <c:v>0.38</c:v>
                </c:pt>
                <c:pt idx="7">
                  <c:v>0.03</c:v>
                </c:pt>
                <c:pt idx="8">
                  <c:v>1.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8E4-4A94-AD3B-B5947B7634CB}"/>
            </c:ext>
          </c:extLst>
        </c:ser>
        <c:ser>
          <c:idx val="6"/>
          <c:order val="6"/>
          <c:tx>
            <c:strRef>
              <c:f>ITS_Phylum_Month!$A$8</c:f>
              <c:strCache>
                <c:ptCount val="1"/>
                <c:pt idx="0">
                  <c:v>Plantae_p</c:v>
                </c:pt>
              </c:strCache>
            </c:strRef>
          </c:tx>
          <c:spPr>
            <a:pattFill prst="ltDnDiag">
              <a:fgClr>
                <a:schemeClr val="accent2">
                  <a:lumMod val="80000"/>
                  <a:lumOff val="20000"/>
                </a:schemeClr>
              </a:fgClr>
              <a:bgClr>
                <a:schemeClr val="accent2">
                  <a:lumMod val="80000"/>
                  <a:lumOff val="20000"/>
                  <a:lumMod val="20000"/>
                  <a:lumOff val="80000"/>
                </a:schemeClr>
              </a:bgClr>
            </a:pattFill>
            <a:ln>
              <a:solidFill>
                <a:schemeClr val="accent2">
                  <a:lumMod val="80000"/>
                  <a:lumOff val="20000"/>
                </a:schemeClr>
              </a:solidFill>
            </a:ln>
            <a:effectLst/>
            <a:sp3d>
              <a:contourClr>
                <a:schemeClr val="accent2">
                  <a:lumMod val="80000"/>
                  <a:lumOff val="20000"/>
                </a:schemeClr>
              </a:contourClr>
            </a:sp3d>
          </c:spPr>
          <c:invertIfNegative val="0"/>
          <c:cat>
            <c:strRef>
              <c:f>ITS_Phylum_Month!$B$1:$J$1</c:f>
              <c:strCache>
                <c:ptCount val="9"/>
                <c:pt idx="0">
                  <c:v>Feb19_SU</c:v>
                </c:pt>
                <c:pt idx="1">
                  <c:v>Apr19-SU</c:v>
                </c:pt>
                <c:pt idx="2">
                  <c:v>Jun19_SU</c:v>
                </c:pt>
                <c:pt idx="3">
                  <c:v>Feb19_Gan</c:v>
                </c:pt>
                <c:pt idx="4">
                  <c:v>Apr19-Gan</c:v>
                </c:pt>
                <c:pt idx="5">
                  <c:v>Jun19_Gan</c:v>
                </c:pt>
                <c:pt idx="6">
                  <c:v>Feb19_Ind</c:v>
                </c:pt>
                <c:pt idx="7">
                  <c:v>Apr19_Ind</c:v>
                </c:pt>
                <c:pt idx="8">
                  <c:v>Jun19-Ind</c:v>
                </c:pt>
              </c:strCache>
            </c:strRef>
          </c:cat>
          <c:val>
            <c:numRef>
              <c:f>ITS_Phylum_Month!$B$8:$J$8</c:f>
              <c:numCache>
                <c:formatCode>General</c:formatCode>
                <c:ptCount val="9"/>
                <c:pt idx="0">
                  <c:v>25.83</c:v>
                </c:pt>
                <c:pt idx="1">
                  <c:v>29.86</c:v>
                </c:pt>
                <c:pt idx="2">
                  <c:v>6.24</c:v>
                </c:pt>
                <c:pt idx="3">
                  <c:v>28.81</c:v>
                </c:pt>
                <c:pt idx="4">
                  <c:v>8.4700000000000006</c:v>
                </c:pt>
                <c:pt idx="5">
                  <c:v>4.63</c:v>
                </c:pt>
                <c:pt idx="6">
                  <c:v>3.39</c:v>
                </c:pt>
                <c:pt idx="7">
                  <c:v>1.07</c:v>
                </c:pt>
                <c:pt idx="8">
                  <c:v>35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8E4-4A94-AD3B-B5947B7634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830721056"/>
        <c:axId val="830718976"/>
        <c:axId val="0"/>
      </c:bar3DChart>
      <c:catAx>
        <c:axId val="83072105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830718976"/>
        <c:crosses val="autoZero"/>
        <c:auto val="1"/>
        <c:lblAlgn val="ctr"/>
        <c:lblOffset val="100"/>
        <c:noMultiLvlLbl val="0"/>
      </c:catAx>
      <c:valAx>
        <c:axId val="830718976"/>
        <c:scaling>
          <c:orientation val="minMax"/>
        </c:scaling>
        <c:delete val="0"/>
        <c:axPos val="l"/>
        <c:majorGridlines>
          <c:spPr>
            <a:ln>
              <a:solidFill>
                <a:schemeClr val="tx1">
                  <a:lumMod val="15000"/>
                  <a:lumOff val="85000"/>
                </a:schemeClr>
              </a:solidFill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</a:t>
                </a:r>
                <a:r>
                  <a:rPr lang="en-US" baseline="0"/>
                  <a:t> Abundance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307210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>
      <cs:styleClr val="auto"/>
    </cs:lnRef>
    <cs:fillRef idx="0">
      <cs:styleClr val="auto"/>
    </cs:fillRef>
    <cs:effectRef idx="0"/>
    <cs:fontRef idx="minor">
      <a:schemeClr val="tx1"/>
    </cs:fontRef>
    <cs:spPr>
      <a:pattFill prst="ltDnDiag">
        <a:fgClr>
          <a:schemeClr val="phClr"/>
        </a:fgClr>
        <a:bgClr>
          <a:schemeClr val="phClr">
            <a:lumMod val="20000"/>
            <a:lumOff val="80000"/>
          </a:schemeClr>
        </a:bgClr>
      </a:pattFill>
      <a:ln>
        <a:solidFill>
          <a:schemeClr val="phClr"/>
        </a:solidFill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8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9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>
      <cs:styleClr val="auto"/>
    </cs:lnRef>
    <cs:fillRef idx="0">
      <cs:styleClr val="auto"/>
    </cs:fillRef>
    <cs:effectRef idx="0"/>
    <cs:fontRef idx="minor">
      <a:schemeClr val="tx1"/>
    </cs:fontRef>
    <cs:spPr>
      <a:pattFill prst="ltDnDiag">
        <a:fgClr>
          <a:schemeClr val="phClr"/>
        </a:fgClr>
        <a:bgClr>
          <a:schemeClr val="phClr">
            <a:lumMod val="20000"/>
            <a:lumOff val="80000"/>
          </a:schemeClr>
        </a:bgClr>
      </a:pattFill>
      <a:ln>
        <a:solidFill>
          <a:schemeClr val="phClr"/>
        </a:solidFill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8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2213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432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105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026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320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052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519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685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318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118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633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9BEFA-021F-4707-9935-933F702718A8}" type="datetimeFigureOut">
              <a:rPr lang="en-US" smtClean="0"/>
              <a:t>03-Ju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2E5F4-1951-49E9-8DBE-B236A3968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954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tif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Relationship Id="rId9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47248" y="1797803"/>
            <a:ext cx="9144000" cy="1611824"/>
          </a:xfrm>
        </p:spPr>
        <p:txBody>
          <a:bodyPr>
            <a:norm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oul Subway Microbiome</a:t>
            </a:r>
            <a:b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</a:t>
            </a:r>
            <a:r>
              <a:rPr lang="en-US" sz="3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_</a:t>
            </a:r>
            <a:r>
              <a:rPr lang="en-US" sz="2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r>
              <a:rPr 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58215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463" y="87085"/>
            <a:ext cx="4912801" cy="251677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463" y="2918651"/>
            <a:ext cx="4850674" cy="248495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6507" y="0"/>
            <a:ext cx="5603047" cy="287038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4772" y="2918651"/>
            <a:ext cx="5354452" cy="274303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14697" y="5718391"/>
            <a:ext cx="9728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S9: Comparison of abundance of major bacterial phyla (Box Plots) at Subway stations and Outdoor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4786940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086" y="0"/>
            <a:ext cx="5564778" cy="285077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046" y="2850779"/>
            <a:ext cx="5317456" cy="272407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2812" y="124098"/>
            <a:ext cx="5322537" cy="272668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2812" y="2850779"/>
            <a:ext cx="5533424" cy="283471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114697" y="5718391"/>
            <a:ext cx="9867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S9: Comparison of abundance of major bacterial genera (Box Plots) at Subway stations and Outdoor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60440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/>
          <a:stretch>
            <a:fillRect/>
          </a:stretch>
        </p:blipFill>
        <p:spPr>
          <a:xfrm>
            <a:off x="2499946" y="422177"/>
            <a:ext cx="5943600" cy="603123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553307" y="5633583"/>
            <a:ext cx="956016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 S1</a:t>
            </a: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Average phylum prevalence in aerosol of SMRT Subway Stations</a:t>
            </a:r>
            <a:endParaRPr lang="en-US" sz="16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5159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>
            <p:extLst>
              <p:ext uri="{D42A27DB-BD31-4B8C-83A1-F6EECF244321}">
                <p14:modId xmlns:p14="http://schemas.microsoft.com/office/powerpoint/2010/main" val="1105198251"/>
              </p:ext>
            </p:extLst>
          </p:nvPr>
        </p:nvGraphicFramePr>
        <p:xfrm>
          <a:off x="3124200" y="1160462"/>
          <a:ext cx="5943600" cy="45370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2247901" y="5820630"/>
            <a:ext cx="897987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</a:rPr>
              <a:t>Fig S2</a:t>
            </a:r>
            <a:r>
              <a:rPr lang="en-US" b="1" dirty="0">
                <a:latin typeface="Times New Roman" panose="02020603050405020304" pitchFamily="18" charset="0"/>
              </a:rPr>
              <a:t>: Month wise comparison of abundant bacterial phylum at SMRT stations.</a:t>
            </a:r>
            <a:endParaRPr lang="en-US" dirty="0" smtClean="0">
              <a:effectLst/>
            </a:endParaRPr>
          </a:p>
          <a:p>
            <a:r>
              <a:rPr lang="en-US" dirty="0" smtClean="0">
                <a:latin typeface="Times New Roman" panose="02020603050405020304" pitchFamily="18" charset="0"/>
              </a:rPr>
              <a:t>Station A, Station B, Station C</a:t>
            </a:r>
            <a:endParaRPr lang="en-US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368188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57200" y="5723682"/>
            <a:ext cx="1153550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</a:rPr>
              <a:t>Fig S3</a:t>
            </a:r>
            <a:r>
              <a:rPr lang="en-US" b="1" dirty="0">
                <a:latin typeface="Times New Roman" panose="02020603050405020304" pitchFamily="18" charset="0"/>
              </a:rPr>
              <a:t>: Indicator Value (</a:t>
            </a:r>
            <a:r>
              <a:rPr lang="en-US" b="1" dirty="0" err="1">
                <a:latin typeface="Times New Roman" panose="02020603050405020304" pitchFamily="18" charset="0"/>
              </a:rPr>
              <a:t>IndVal</a:t>
            </a:r>
            <a:r>
              <a:rPr lang="en-US" b="1" dirty="0">
                <a:latin typeface="Times New Roman" panose="02020603050405020304" pitchFamily="18" charset="0"/>
              </a:rPr>
              <a:t>%) Analysis for major phyla of SMRT Subway Stations.</a:t>
            </a:r>
            <a:endParaRPr lang="en-US" dirty="0" smtClean="0">
              <a:effectLst/>
            </a:endParaRPr>
          </a:p>
          <a:p>
            <a:r>
              <a:rPr lang="en-US" dirty="0">
                <a:latin typeface="Times New Roman" panose="02020603050405020304" pitchFamily="18" charset="0"/>
              </a:rPr>
              <a:t>Significant change in the phylum during different months at stations was evaluated. </a:t>
            </a:r>
            <a:endParaRPr lang="en-US" dirty="0" smtClean="0">
              <a:effectLst/>
            </a:endParaRPr>
          </a:p>
          <a:p>
            <a:r>
              <a:rPr lang="en-US" dirty="0">
                <a:latin typeface="Times New Roman" panose="02020603050405020304" pitchFamily="18" charset="0"/>
              </a:rPr>
              <a:t>(P&lt;0.05 boxed). </a:t>
            </a:r>
            <a:endParaRPr lang="en-US" dirty="0">
              <a:effectLst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2030" y="1057475"/>
            <a:ext cx="4892583" cy="4546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63496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125415" y="4978104"/>
            <a:ext cx="10445261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 S4</a:t>
            </a: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: Major genera present at 3 </a:t>
            </a: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MRT (Station A, Station B, Station C</a:t>
            </a:r>
            <a:endParaRPr lang="en-US" sz="16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9070" y="272587"/>
            <a:ext cx="6377223" cy="3960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2482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Users\user\Downloads\MTPSET_Composition_Genus (4).pn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7677" y="666041"/>
            <a:ext cx="5943600" cy="353885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228600" y="4701598"/>
            <a:ext cx="1150913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</a:rPr>
              <a:t>Fig S5</a:t>
            </a: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</a:rPr>
              <a:t>: Month wise comparison of major 16S bacterial genera at SMRT stations.  The samples from all 3 stations in this study were collected during February 2019, April 2019 and June 2019. Cut-off% was taken as 1.0%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70045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055" y="1120897"/>
            <a:ext cx="3532505" cy="3584575"/>
          </a:xfrm>
          <a:prstGeom prst="rect">
            <a:avLst/>
          </a:prstGeom>
        </p:spPr>
      </p:pic>
      <p:sp>
        <p:nvSpPr>
          <p:cNvPr id="3" name="Text Box 2"/>
          <p:cNvSpPr txBox="1">
            <a:spLocks noChangeArrowheads="1"/>
          </p:cNvSpPr>
          <p:nvPr/>
        </p:nvSpPr>
        <p:spPr bwMode="auto">
          <a:xfrm>
            <a:off x="422055" y="3744839"/>
            <a:ext cx="1038860" cy="35306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800" b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verage Phylum Abundance of ITS</a:t>
            </a:r>
            <a:endParaRPr lang="en-US" sz="110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2954" y="1120897"/>
            <a:ext cx="6664646" cy="254184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5815" y="3545509"/>
            <a:ext cx="5814786" cy="3314259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40677" y="4918724"/>
            <a:ext cx="6096000" cy="685059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6: </a:t>
            </a: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ajor Fungal Phyla, Class and Genus identified at 3 SMRT </a:t>
            </a: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tations.</a:t>
            </a:r>
            <a:endParaRPr lang="en-US" sz="16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0423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-168442" y="161389"/>
          <a:ext cx="5481487" cy="34881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 rot="18724952">
            <a:off x="3040587" y="3581960"/>
            <a:ext cx="545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Apr19_C  </a:t>
            </a:r>
            <a:endParaRPr lang="en-US" sz="800" dirty="0"/>
          </a:p>
        </p:txBody>
      </p:sp>
      <p:sp>
        <p:nvSpPr>
          <p:cNvPr id="4" name="TextBox 3"/>
          <p:cNvSpPr txBox="1"/>
          <p:nvPr/>
        </p:nvSpPr>
        <p:spPr>
          <a:xfrm rot="18724952">
            <a:off x="729919" y="3541857"/>
            <a:ext cx="545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Apr19_A   </a:t>
            </a:r>
            <a:endParaRPr lang="en-US" sz="800" dirty="0"/>
          </a:p>
        </p:txBody>
      </p:sp>
      <p:sp>
        <p:nvSpPr>
          <p:cNvPr id="5" name="TextBox 4"/>
          <p:cNvSpPr txBox="1"/>
          <p:nvPr/>
        </p:nvSpPr>
        <p:spPr>
          <a:xfrm rot="18724952">
            <a:off x="1114931" y="3557897"/>
            <a:ext cx="545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Jun19_A   </a:t>
            </a:r>
            <a:endParaRPr lang="en-US" sz="800" dirty="0"/>
          </a:p>
        </p:txBody>
      </p:sp>
      <p:sp>
        <p:nvSpPr>
          <p:cNvPr id="6" name="TextBox 5"/>
          <p:cNvSpPr txBox="1"/>
          <p:nvPr/>
        </p:nvSpPr>
        <p:spPr>
          <a:xfrm rot="18724952">
            <a:off x="1481864" y="3573937"/>
            <a:ext cx="545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Feb19_B   </a:t>
            </a:r>
            <a:endParaRPr lang="en-US" sz="800" dirty="0"/>
          </a:p>
        </p:txBody>
      </p:sp>
      <p:sp>
        <p:nvSpPr>
          <p:cNvPr id="7" name="TextBox 6"/>
          <p:cNvSpPr txBox="1"/>
          <p:nvPr/>
        </p:nvSpPr>
        <p:spPr>
          <a:xfrm rot="18724952">
            <a:off x="1892975" y="3589982"/>
            <a:ext cx="545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Apr19_B  </a:t>
            </a:r>
            <a:endParaRPr lang="en-US" sz="800" dirty="0"/>
          </a:p>
        </p:txBody>
      </p:sp>
      <p:sp>
        <p:nvSpPr>
          <p:cNvPr id="8" name="TextBox 7"/>
          <p:cNvSpPr txBox="1"/>
          <p:nvPr/>
        </p:nvSpPr>
        <p:spPr>
          <a:xfrm rot="18724952">
            <a:off x="2234765" y="3614047"/>
            <a:ext cx="545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Jun19_B   </a:t>
            </a:r>
            <a:endParaRPr lang="en-US" sz="800" dirty="0"/>
          </a:p>
        </p:txBody>
      </p:sp>
      <p:sp>
        <p:nvSpPr>
          <p:cNvPr id="9" name="TextBox 8"/>
          <p:cNvSpPr txBox="1"/>
          <p:nvPr/>
        </p:nvSpPr>
        <p:spPr>
          <a:xfrm rot="18724952">
            <a:off x="2640515" y="3589983"/>
            <a:ext cx="545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Feb19_C   </a:t>
            </a:r>
            <a:endParaRPr lang="en-US" sz="800" dirty="0"/>
          </a:p>
        </p:txBody>
      </p:sp>
      <p:sp>
        <p:nvSpPr>
          <p:cNvPr id="10" name="TextBox 9"/>
          <p:cNvSpPr txBox="1"/>
          <p:nvPr/>
        </p:nvSpPr>
        <p:spPr>
          <a:xfrm rot="18724952">
            <a:off x="378050" y="3573938"/>
            <a:ext cx="545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Feb19_A   </a:t>
            </a:r>
            <a:endParaRPr lang="en-US" sz="800" dirty="0"/>
          </a:p>
        </p:txBody>
      </p:sp>
      <p:sp>
        <p:nvSpPr>
          <p:cNvPr id="11" name="TextBox 10"/>
          <p:cNvSpPr txBox="1"/>
          <p:nvPr/>
        </p:nvSpPr>
        <p:spPr>
          <a:xfrm rot="18724952">
            <a:off x="3426040" y="3589982"/>
            <a:ext cx="545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Jun19_C   </a:t>
            </a:r>
            <a:endParaRPr lang="en-US" sz="800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3045" y="715479"/>
            <a:ext cx="5298807" cy="188920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9693" y="2911643"/>
            <a:ext cx="5578212" cy="2894816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127955" y="4203668"/>
            <a:ext cx="5254171" cy="981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 S7: </a:t>
            </a: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ajor Fungal Phyla, Classes and Genera in Comparison during the three months of sampling from all SMRT stations in this study.</a:t>
            </a:r>
            <a:endParaRPr lang="en-US" sz="16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7683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37" y="379709"/>
            <a:ext cx="2620908" cy="215029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3200" y="349118"/>
            <a:ext cx="2658194" cy="218088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2523" y="379709"/>
            <a:ext cx="2578029" cy="211511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0552" y="465757"/>
            <a:ext cx="2435862" cy="199847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37" y="2560592"/>
            <a:ext cx="2691147" cy="220791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7298" y="2550279"/>
            <a:ext cx="2454259" cy="201356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7732" y="2550279"/>
            <a:ext cx="2549204" cy="209146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7684" y="2518070"/>
            <a:ext cx="2810048" cy="230547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489675" y="5059792"/>
            <a:ext cx="10376114" cy="981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 S8: </a:t>
            </a: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ungal α-diversity indices between the 3 SMRT stations. 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bundance-based coverage estimator (ACE), singleton based (CHAO1), jackknife, no. of OUT found, and diversity indices; Non-parametric Shannon (</a:t>
            </a:r>
            <a:r>
              <a:rPr lang="en-US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PShannon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, Shannon, Simpson and phylogenetic diversity (Wilcoxon rank-sum test </a:t>
            </a:r>
            <a:r>
              <a:rPr lang="en-US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</a:t>
            </a:r>
            <a:r>
              <a:rPr lang="en-US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&lt;0.05).</a:t>
            </a:r>
            <a:endParaRPr lang="en-US" sz="16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3220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7</TotalTime>
  <Words>295</Words>
  <Application>Microsoft Office PowerPoint</Application>
  <PresentationFormat>Widescreen</PresentationFormat>
  <Paragraphs>27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Malgun Gothic</vt:lpstr>
      <vt:lpstr>Arial</vt:lpstr>
      <vt:lpstr>Calibri</vt:lpstr>
      <vt:lpstr>Calibri Light</vt:lpstr>
      <vt:lpstr>Times New Roman</vt:lpstr>
      <vt:lpstr>Office Theme</vt:lpstr>
      <vt:lpstr>Seoul Subway Microbiome Supp_Figures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HAIB UL HASSAN</dc:creator>
  <cp:lastModifiedBy>ZOHAIB UL HASSAN</cp:lastModifiedBy>
  <cp:revision>22</cp:revision>
  <dcterms:created xsi:type="dcterms:W3CDTF">2021-05-31T11:18:30Z</dcterms:created>
  <dcterms:modified xsi:type="dcterms:W3CDTF">2022-06-03T05:35:22Z</dcterms:modified>
</cp:coreProperties>
</file>